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814" autoAdjust="0"/>
  </p:normalViewPr>
  <p:slideViewPr>
    <p:cSldViewPr>
      <p:cViewPr varScale="1">
        <p:scale>
          <a:sx n="86" d="100"/>
          <a:sy n="86" d="100"/>
        </p:scale>
        <p:origin x="318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13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18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5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93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66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88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62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35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7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11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506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45"/>
          <a:stretch/>
        </p:blipFill>
        <p:spPr bwMode="auto">
          <a:xfrm>
            <a:off x="502766" y="951877"/>
            <a:ext cx="3344184" cy="26295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2456" y="1892016"/>
            <a:ext cx="1606088" cy="21315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8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1" t="19213" r="13805"/>
          <a:stretch/>
        </p:blipFill>
        <p:spPr bwMode="auto">
          <a:xfrm>
            <a:off x="1799773" y="3700382"/>
            <a:ext cx="2459750" cy="2016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74191" y="8103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59523" y="81034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93350" y="4830438"/>
            <a:ext cx="6415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9695447">
            <a:off x="1397571" y="5168183"/>
            <a:ext cx="3930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9695447">
            <a:off x="962885" y="5160657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X1-</a:t>
            </a:r>
            <a:r>
              <a:rPr lang="en-US" sz="105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endParaRPr lang="en-US" sz="105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34872" y="4146569"/>
            <a:ext cx="573558" cy="1011141"/>
          </a:xfrm>
          <a:prstGeom prst="rect">
            <a:avLst/>
          </a:prstGeom>
        </p:spPr>
      </p:pic>
      <p:pic>
        <p:nvPicPr>
          <p:cNvPr id="16" name="Picture 1" descr="image00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162848" y="1375782"/>
            <a:ext cx="2007449" cy="199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" descr="image00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476"/>
          <a:stretch/>
        </p:blipFill>
        <p:spPr bwMode="auto">
          <a:xfrm>
            <a:off x="4162848" y="1736255"/>
            <a:ext cx="2007449" cy="2432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474191" y="33806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91176" y="1122778"/>
            <a:ext cx="3850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338947" y="1122778"/>
            <a:ext cx="60465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X1-</a:t>
            </a:r>
            <a:r>
              <a:rPr lang="en-US" sz="105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endParaRPr lang="en-US" sz="105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4191000" y="1335666"/>
            <a:ext cx="60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105400" y="1336265"/>
            <a:ext cx="914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07483" y="5867400"/>
            <a:ext cx="5527203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ost-natal reductions in ATX expressio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th MX1-Cre mediated deletion. 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lative gene expression in different tissues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dark bars) and MX1-Δ (open bars) male mice (n = 6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analysi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ATX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 in plasma (1 </a:t>
            </a:r>
            <a:r>
              <a:rPr lang="en-US" sz="11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; bottom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oading control = albumin)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sma ATX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tivity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min/ml)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dark bars) and MX1-Δ (open bars) male mice (n =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6-7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analysis of ATX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tein expression i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bcutaneous fat (loading control </a:t>
            </a:r>
            <a:r>
              <a:rPr lang="en-US" sz="11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) and quantification of ATX expression in fa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dark bars) and MX1-Δ (open bars) mal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ice.</a:t>
            </a:r>
            <a:endParaRPr lang="en-US" sz="800" dirty="0"/>
          </a:p>
        </p:txBody>
      </p:sp>
      <p:sp>
        <p:nvSpPr>
          <p:cNvPr id="25" name="TextBox 24"/>
          <p:cNvSpPr txBox="1"/>
          <p:nvPr/>
        </p:nvSpPr>
        <p:spPr>
          <a:xfrm>
            <a:off x="707483" y="4184166"/>
            <a:ext cx="4539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X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188380" y="1736255"/>
            <a:ext cx="6992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188380" y="1338937"/>
            <a:ext cx="4539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X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3733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133</Words>
  <Application>Microsoft Office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5</cp:revision>
  <cp:lastPrinted>2018-10-21T18:40:01Z</cp:lastPrinted>
  <dcterms:created xsi:type="dcterms:W3CDTF">2018-10-08T19:40:09Z</dcterms:created>
  <dcterms:modified xsi:type="dcterms:W3CDTF">2018-11-15T15:13:02Z</dcterms:modified>
</cp:coreProperties>
</file>